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25" r:id="rId2"/>
    <p:sldId id="326" r:id="rId3"/>
    <p:sldId id="274" r:id="rId4"/>
    <p:sldId id="327" r:id="rId5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126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5000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086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12127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1953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92071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2745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72171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0006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1590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735226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59794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6C0CC6-2C99-4AD3-A732-A9FEA41D4E93}" type="datetimeFigureOut">
              <a:rPr lang="en-IN" smtClean="0"/>
              <a:t>11-04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51915-902F-4390-8753-307B46AFBCD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7792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F36167E-2E49-4BA8-A69D-54664882DB00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70" t="31869" r="8333" b="15526"/>
          <a:stretch/>
        </p:blipFill>
        <p:spPr bwMode="auto">
          <a:xfrm>
            <a:off x="529746" y="1507932"/>
            <a:ext cx="9122955" cy="352715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C01AAF1-6C3C-4ED6-9913-3B83A41C835F}"/>
              </a:ext>
            </a:extLst>
          </p:cNvPr>
          <p:cNvSpPr txBox="1"/>
          <p:nvPr/>
        </p:nvSpPr>
        <p:spPr>
          <a:xfrm>
            <a:off x="704644" y="1138600"/>
            <a:ext cx="36804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NA-3-methyladenine glycosylase I</a:t>
            </a:r>
            <a:endParaRPr lang="en-IN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9B3D5AF-411E-4249-8901-5AA0462AE0F7}"/>
              </a:ext>
            </a:extLst>
          </p:cNvPr>
          <p:cNvSpPr txBox="1"/>
          <p:nvPr/>
        </p:nvSpPr>
        <p:spPr>
          <a:xfrm>
            <a:off x="5368084" y="1141894"/>
            <a:ext cx="39446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arbon catabolite repressor 4b (CCR4b)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858495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5677632-2C9E-46D2-A3F2-8CBA241218D1}"/>
              </a:ext>
            </a:extLst>
          </p:cNvPr>
          <p:cNvSpPr txBox="1"/>
          <p:nvPr/>
        </p:nvSpPr>
        <p:spPr>
          <a:xfrm>
            <a:off x="4052570" y="396212"/>
            <a:ext cx="18008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solidFill>
                  <a:srgbClr val="00000A"/>
                </a:solidFill>
                <a:effectLst/>
                <a:latin typeface="Calibri" panose="020F0502020204030204" pitchFamily="34" charset="0"/>
                <a:ea typeface="Droid Sans Fallback"/>
              </a:rPr>
              <a:t>HUA enhancer 2</a:t>
            </a:r>
            <a:endParaRPr lang="en-IN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5427D4A-E8D7-4D7F-B08F-4909B2E3BDD1}"/>
              </a:ext>
            </a:extLst>
          </p:cNvPr>
          <p:cNvGrpSpPr/>
          <p:nvPr/>
        </p:nvGrpSpPr>
        <p:grpSpPr>
          <a:xfrm>
            <a:off x="2550042" y="874587"/>
            <a:ext cx="4805915" cy="4632125"/>
            <a:chOff x="1488559" y="895852"/>
            <a:chExt cx="4805915" cy="463212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80A7835-8FC7-465A-961A-580E2B82E757}"/>
                </a:ext>
              </a:extLst>
            </p:cNvPr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109" t="50762" r="23397" b="13057"/>
            <a:stretch/>
          </p:blipFill>
          <p:spPr bwMode="auto">
            <a:xfrm>
              <a:off x="1488559" y="2838891"/>
              <a:ext cx="4805915" cy="2689086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CBD91D2-72FC-40D7-AAC4-265E6F23D090}"/>
                </a:ext>
              </a:extLst>
            </p:cNvPr>
            <p:cNvSpPr txBox="1"/>
            <p:nvPr/>
          </p:nvSpPr>
          <p:spPr>
            <a:xfrm rot="18259253">
              <a:off x="3162829" y="2370902"/>
              <a:ext cx="8740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arker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67EA563-2A97-41C1-84E0-24BF3037AC03}"/>
                </a:ext>
              </a:extLst>
            </p:cNvPr>
            <p:cNvSpPr txBox="1"/>
            <p:nvPr/>
          </p:nvSpPr>
          <p:spPr>
            <a:xfrm rot="18259253">
              <a:off x="1441516" y="2178285"/>
              <a:ext cx="13404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RN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261FC23-97B1-4040-A7D9-33DDC48344B4}"/>
                </a:ext>
              </a:extLst>
            </p:cNvPr>
            <p:cNvSpPr txBox="1"/>
            <p:nvPr/>
          </p:nvSpPr>
          <p:spPr>
            <a:xfrm rot="18259253">
              <a:off x="1670116" y="2178285"/>
              <a:ext cx="13404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Water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094F014-9D2F-4824-9584-FA9E6760652E}"/>
                </a:ext>
              </a:extLst>
            </p:cNvPr>
            <p:cNvSpPr txBox="1"/>
            <p:nvPr/>
          </p:nvSpPr>
          <p:spPr>
            <a:xfrm rot="18259253">
              <a:off x="2058575" y="2011417"/>
              <a:ext cx="17445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Infected1-5.8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5D87868-3E6E-4E1E-BEEE-587E8BE2FCC8}"/>
                </a:ext>
              </a:extLst>
            </p:cNvPr>
            <p:cNvSpPr txBox="1"/>
            <p:nvPr/>
          </p:nvSpPr>
          <p:spPr>
            <a:xfrm rot="18259253">
              <a:off x="2222247" y="1888475"/>
              <a:ext cx="20422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Uninfected1-cDN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9D2864C-9737-4FDB-810D-32406410B76B}"/>
                </a:ext>
              </a:extLst>
            </p:cNvPr>
            <p:cNvSpPr txBox="1"/>
            <p:nvPr/>
          </p:nvSpPr>
          <p:spPr>
            <a:xfrm rot="18259253">
              <a:off x="2419673" y="1831768"/>
              <a:ext cx="21796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Uninfected2-cDNA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5739D66-FE96-45AF-98CD-C7B9F5929AD5}"/>
                </a:ext>
              </a:extLst>
            </p:cNvPr>
            <p:cNvSpPr txBox="1"/>
            <p:nvPr/>
          </p:nvSpPr>
          <p:spPr>
            <a:xfrm rot="18259253">
              <a:off x="3136648" y="1888475"/>
              <a:ext cx="20422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Infected 24h2-cDN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B5401FB-44C7-40F8-9A15-C501434C9C1F}"/>
                </a:ext>
              </a:extLst>
            </p:cNvPr>
            <p:cNvSpPr txBox="1"/>
            <p:nvPr/>
          </p:nvSpPr>
          <p:spPr>
            <a:xfrm rot="18259253">
              <a:off x="3365248" y="1888475"/>
              <a:ext cx="20422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Infected 36h1-cDN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EF80E87-3B47-4C40-95DE-53995B38DD15}"/>
                </a:ext>
              </a:extLst>
            </p:cNvPr>
            <p:cNvSpPr txBox="1"/>
            <p:nvPr/>
          </p:nvSpPr>
          <p:spPr>
            <a:xfrm rot="18259253">
              <a:off x="1811351" y="2011417"/>
              <a:ext cx="17445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Uninfected1-5.8s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E152551C-6565-4955-87F5-5318CD9D5075}"/>
                </a:ext>
              </a:extLst>
            </p:cNvPr>
            <p:cNvSpPr/>
            <p:nvPr/>
          </p:nvSpPr>
          <p:spPr>
            <a:xfrm rot="18371625">
              <a:off x="2784037" y="2061770"/>
              <a:ext cx="165038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Infected 24h1-cDNA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EE64F40C-0B4C-4671-B9D3-F98462832120}"/>
                </a:ext>
              </a:extLst>
            </p:cNvPr>
            <p:cNvSpPr/>
            <p:nvPr/>
          </p:nvSpPr>
          <p:spPr>
            <a:xfrm rot="18329084">
              <a:off x="3691274" y="2057335"/>
              <a:ext cx="165038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Infected 36h2-cDNA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6581BC70-D9BA-472B-BC3C-99D3B150A1D9}"/>
                </a:ext>
              </a:extLst>
            </p:cNvPr>
            <p:cNvSpPr/>
            <p:nvPr/>
          </p:nvSpPr>
          <p:spPr>
            <a:xfrm rot="18405759">
              <a:off x="3932717" y="2065413"/>
              <a:ext cx="165038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Infected 48h1-cDNA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17B82264-0680-4BC9-BF90-47FCCE07443E}"/>
                </a:ext>
              </a:extLst>
            </p:cNvPr>
            <p:cNvSpPr/>
            <p:nvPr/>
          </p:nvSpPr>
          <p:spPr>
            <a:xfrm rot="18385067">
              <a:off x="4183984" y="2063196"/>
              <a:ext cx="165038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Infected 48h2-cDNA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D37E6AD9-7FA2-460E-9CB8-F7509A57C6F6}"/>
                </a:ext>
              </a:extLst>
            </p:cNvPr>
            <p:cNvSpPr/>
            <p:nvPr/>
          </p:nvSpPr>
          <p:spPr>
            <a:xfrm rot="18431832">
              <a:off x="4491649" y="2111021"/>
              <a:ext cx="154298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Infected 48h2-5.8s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AFE20755-60E3-49DB-8E3C-E5BBDA2E138E}"/>
                </a:ext>
              </a:extLst>
            </p:cNvPr>
            <p:cNvSpPr/>
            <p:nvPr/>
          </p:nvSpPr>
          <p:spPr>
            <a:xfrm rot="18431832">
              <a:off x="4877239" y="1981416"/>
              <a:ext cx="186839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Uninfected 48h2- Actin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38E7FD23-A7BF-4C2E-9DE2-C1626E52BE14}"/>
                </a:ext>
              </a:extLst>
            </p:cNvPr>
            <p:cNvSpPr/>
            <p:nvPr/>
          </p:nvSpPr>
          <p:spPr>
            <a:xfrm rot="18431832">
              <a:off x="5138176" y="2079737"/>
              <a:ext cx="16215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Infected 48h2-Actin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D39CA389-650C-4C59-B3E4-3CF2DE5F4696}"/>
                </a:ext>
              </a:extLst>
            </p:cNvPr>
            <p:cNvSpPr/>
            <p:nvPr/>
          </p:nvSpPr>
          <p:spPr>
            <a:xfrm rot="18431832">
              <a:off x="4908803" y="2465894"/>
              <a:ext cx="65197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/>
                <a:t>Empt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699312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BC083290-D6C3-4284-A20D-7BDAC850F4D2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61" t="36463" r="43649" b="14123"/>
          <a:stretch/>
        </p:blipFill>
        <p:spPr bwMode="auto">
          <a:xfrm>
            <a:off x="2825336" y="1152923"/>
            <a:ext cx="4255327" cy="37186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B5746AB-257F-499D-AEB7-7D12B4D55F8A}"/>
              </a:ext>
            </a:extLst>
          </p:cNvPr>
          <p:cNvSpPr txBox="1"/>
          <p:nvPr/>
        </p:nvSpPr>
        <p:spPr>
          <a:xfrm>
            <a:off x="4265929" y="708287"/>
            <a:ext cx="1374140" cy="3726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rgonaute2 </a:t>
            </a:r>
            <a:endParaRPr lang="en-IN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ABA6A06-372A-4EC0-A734-6B73A78A1E1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235" t="9833" r="21968" b="10596"/>
          <a:stretch/>
        </p:blipFill>
        <p:spPr>
          <a:xfrm>
            <a:off x="2606625" y="882393"/>
            <a:ext cx="4635796" cy="443377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FAF2854-DE96-400F-ADB0-1758132DBAD5}"/>
              </a:ext>
            </a:extLst>
          </p:cNvPr>
          <p:cNvSpPr txBox="1"/>
          <p:nvPr/>
        </p:nvSpPr>
        <p:spPr>
          <a:xfrm>
            <a:off x="3950970" y="542259"/>
            <a:ext cx="2004060" cy="3726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entatricopeptide</a:t>
            </a:r>
            <a:endParaRPr lang="en-IN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8EE7DBD-8358-490A-A033-36F259883E42}"/>
              </a:ext>
            </a:extLst>
          </p:cNvPr>
          <p:cNvSpPr txBox="1"/>
          <p:nvPr/>
        </p:nvSpPr>
        <p:spPr>
          <a:xfrm>
            <a:off x="291161" y="5390831"/>
            <a:ext cx="9266723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4: </a:t>
            </a:r>
            <a:r>
              <a:rPr lang="en-IN" sz="1400" dirty="0">
                <a:solidFill>
                  <a:srgbClr val="00000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</a:t>
            </a:r>
            <a:r>
              <a:rPr lang="en-IN" sz="1400" dirty="0">
                <a:solidFill>
                  <a:srgbClr val="00000A"/>
                </a:solidFill>
                <a:effectLst/>
                <a:latin typeface="Calibri" panose="020F0502020204030204" pitchFamily="34" charset="0"/>
                <a:ea typeface="Droid Sans Fallback"/>
              </a:rPr>
              <a:t>emi-quantitative PCR of miRNA target gene. Semi-quantitative PCR was carried out for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NA-3-methyladenine glycosylase I, Carbon catabolite repressor 4b (CCR4b), </a:t>
            </a:r>
            <a:r>
              <a:rPr lang="en-IN" sz="1400" dirty="0">
                <a:solidFill>
                  <a:srgbClr val="00000A"/>
                </a:solidFill>
                <a:effectLst/>
                <a:latin typeface="Calibri" panose="020F0502020204030204" pitchFamily="34" charset="0"/>
                <a:ea typeface="Droid Sans Fallback"/>
              </a:rPr>
              <a:t>HUA enhancer 2,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rgonaute2 </a:t>
            </a:r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and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entatricopeptide </a:t>
            </a:r>
            <a:r>
              <a:rPr lang="en-IN" sz="1400" dirty="0">
                <a:solidFill>
                  <a:srgbClr val="00000A"/>
                </a:solidFill>
                <a:effectLst/>
                <a:latin typeface="Calibri" panose="020F0502020204030204" pitchFamily="34" charset="0"/>
                <a:ea typeface="Droid Sans Fallback"/>
              </a:rPr>
              <a:t>specific genes </a:t>
            </a:r>
            <a:r>
              <a:rPr lang="en-US" sz="1400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for uninfected and infected samples at different time points post </a:t>
            </a:r>
            <a:r>
              <a:rPr lang="en-US" sz="1400" i="1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R. </a:t>
            </a:r>
            <a:r>
              <a:rPr lang="en-US" sz="1400" i="1" dirty="0" err="1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solani</a:t>
            </a:r>
            <a:r>
              <a:rPr lang="en-US" sz="1400" dirty="0"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 infection along with negative (water, RNA) and positive controls (5.8s and/or actin). 1Kb plus ladder (7</a:t>
            </a:r>
            <a:r>
              <a:rPr lang="en-US" sz="1400" dirty="0">
                <a:ea typeface="Times New Roman" panose="02020603050405020304" pitchFamily="18" charset="0"/>
              </a:rPr>
              <a:t>5-20,000 bp) (Gene ruler, Thermo scientific) was used as reference marker.</a:t>
            </a:r>
            <a:endParaRPr lang="en-IN" sz="1400" dirty="0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A812318-7897-460C-A6D0-E94398B5D9C0}"/>
              </a:ext>
            </a:extLst>
          </p:cNvPr>
          <p:cNvCxnSpPr/>
          <p:nvPr/>
        </p:nvCxnSpPr>
        <p:spPr>
          <a:xfrm>
            <a:off x="6358265" y="4795284"/>
            <a:ext cx="34024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9C520754-B025-41AF-B2DA-C587D1EB3E2B}"/>
              </a:ext>
            </a:extLst>
          </p:cNvPr>
          <p:cNvSpPr txBox="1"/>
          <p:nvPr/>
        </p:nvSpPr>
        <p:spPr>
          <a:xfrm>
            <a:off x="6655976" y="4610618"/>
            <a:ext cx="11164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120 bp</a:t>
            </a:r>
          </a:p>
        </p:txBody>
      </p:sp>
    </p:spTree>
    <p:extLst>
      <p:ext uri="{BB962C8B-B14F-4D97-AF65-F5344CB8AC3E}">
        <p14:creationId xmlns:p14="http://schemas.microsoft.com/office/powerpoint/2010/main" val="2150382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</TotalTime>
  <Words>133</Words>
  <Application>Microsoft Office PowerPoint</Application>
  <PresentationFormat>A4 Paper (210x297 mm)</PresentationFormat>
  <Paragraphs>2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IRBAD GURIA</dc:creator>
  <cp:lastModifiedBy>Nagesh S</cp:lastModifiedBy>
  <cp:revision>14</cp:revision>
  <dcterms:created xsi:type="dcterms:W3CDTF">2022-02-04T02:18:58Z</dcterms:created>
  <dcterms:modified xsi:type="dcterms:W3CDTF">2022-04-11T09:55:27Z</dcterms:modified>
</cp:coreProperties>
</file>